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1584007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ADA2C5-625A-49BD-916B-11D2B8A5593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843120"/>
            <a:ext cx="5914800" cy="3062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4216320"/>
            <a:ext cx="591480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9465840"/>
            <a:ext cx="591480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4FC486-31DA-4F2C-AAE8-C3989BA13F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843120"/>
            <a:ext cx="5914800" cy="3062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4216320"/>
            <a:ext cx="288612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4216320"/>
            <a:ext cx="288612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9465840"/>
            <a:ext cx="288612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9465840"/>
            <a:ext cx="288612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45ACA5-9341-473A-AB34-9E02E9D66C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843120"/>
            <a:ext cx="5914800" cy="3062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4216320"/>
            <a:ext cx="190440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4216320"/>
            <a:ext cx="190440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4216320"/>
            <a:ext cx="190440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9465840"/>
            <a:ext cx="190440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9465840"/>
            <a:ext cx="190440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9465840"/>
            <a:ext cx="190440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66E626-5B11-4DDE-BEAF-73E96AAE10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843120"/>
            <a:ext cx="5914800" cy="3062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4216320"/>
            <a:ext cx="5914800" cy="10050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F4EF8E-3126-4639-BAE7-8001DE44BE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843120"/>
            <a:ext cx="5914800" cy="3062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4216320"/>
            <a:ext cx="5914800" cy="1005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69A444-F440-40DF-92EA-33C936E9CA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843120"/>
            <a:ext cx="5914800" cy="3062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4216320"/>
            <a:ext cx="2886120" cy="1005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4216320"/>
            <a:ext cx="2886120" cy="1005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8D3F08-5A30-4347-83E4-61121AE8E5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843120"/>
            <a:ext cx="5914800" cy="3062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6F3D17-29AA-4558-8596-5A3FE33530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843120"/>
            <a:ext cx="5914800" cy="14195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598C3B-D54F-4981-83C0-04F9AC36AF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843120"/>
            <a:ext cx="5914800" cy="3062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4216320"/>
            <a:ext cx="288612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4216320"/>
            <a:ext cx="2886120" cy="1005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9465840"/>
            <a:ext cx="288612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7805EF-EC47-4C0E-B87C-659129B2E4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843120"/>
            <a:ext cx="5914800" cy="3062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4216320"/>
            <a:ext cx="2886120" cy="1005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4216320"/>
            <a:ext cx="288612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9465840"/>
            <a:ext cx="288612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E02A81-F229-4C8E-BDB2-7B46DAE12B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843120"/>
            <a:ext cx="5914800" cy="3062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4216320"/>
            <a:ext cx="288612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4216320"/>
            <a:ext cx="288612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9465840"/>
            <a:ext cx="5914800" cy="47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0FC0BF-08F3-4EC9-9E10-E39E822B51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843120"/>
            <a:ext cx="5914800" cy="3062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4216320"/>
            <a:ext cx="5914800" cy="1005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14681160"/>
            <a:ext cx="1542960" cy="84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GB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14681160"/>
            <a:ext cx="2314800" cy="84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14681160"/>
            <a:ext cx="1542960" cy="84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GB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72EB1C6-7B5E-47A9-9048-77AC866AEF45}" type="slidenum">
              <a:rPr b="0" lang="en-GB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6080" y="2995560"/>
          <a:ext cx="6765840" cy="3451320"/>
        </p:xfrm>
        <a:graphic>
          <a:graphicData uri="http://schemas.openxmlformats.org/drawingml/2006/table">
            <a:tbl>
              <a:tblPr/>
              <a:tblGrid>
                <a:gridCol w="374760"/>
                <a:gridCol w="131760"/>
                <a:gridCol w="447480"/>
                <a:gridCol w="517680"/>
                <a:gridCol w="803160"/>
                <a:gridCol w="720720"/>
                <a:gridCol w="701640"/>
                <a:gridCol w="344520"/>
                <a:gridCol w="2724120"/>
              </a:tblGrid>
              <a:tr h="336600"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ffc000"/>
                      </a:solidFill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z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S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ppro.P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uster Siz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cat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99880">
                <a:tc gridSpan="9"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ositive Salience Region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ffc000"/>
                      </a:solidFill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00240"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3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ffc000"/>
                      </a:solidFill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628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9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iddle frontal gyrus, precentral gyru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46040"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6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ffc000"/>
                      </a:solidFill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4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.117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2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t-BR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upramarginal gyrus (posterior), parietal operculum cortex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01680"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ffc000"/>
                      </a:solidFill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888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eft caudat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46040"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ffc000"/>
                      </a:solidFill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768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1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ontal operculum cortex, inferior frontal gyrus (pars triangulari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46040"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4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ffc000"/>
                      </a:solidFill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4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594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4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emporal fusiform cortex (posterior), inferior temporal gyrus (posterior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92320"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1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ffc000"/>
                      </a:solidFill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7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148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tracalcarine cortex, precuneous cortex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90160">
                <a:tc gridSpan="9"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i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egative Salience Region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ffc000"/>
                      </a:solidFill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92320"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4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ffc000"/>
                      </a:solidFill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7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5.135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ateral occipital cortex (superior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pic>
        <p:nvPicPr>
          <p:cNvPr id="42" name="Picture 4" descr="A brain with different colored spots&#10;&#10;Description automatically generated"/>
          <p:cNvPicPr/>
          <p:nvPr/>
        </p:nvPicPr>
        <p:blipFill>
          <a:blip r:embed="rId1"/>
          <a:srcRect l="32695" t="18682" r="32276" b="21240"/>
          <a:stretch/>
        </p:blipFill>
        <p:spPr>
          <a:xfrm>
            <a:off x="108000" y="830160"/>
            <a:ext cx="2571840" cy="21654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A close up of a brain&#10;&#10;Description automatically generated"/>
          <p:cNvPicPr/>
          <p:nvPr/>
        </p:nvPicPr>
        <p:blipFill>
          <a:blip r:embed="rId2"/>
          <a:srcRect l="35828" t="21980" r="37096" b="21240"/>
          <a:stretch/>
        </p:blipFill>
        <p:spPr>
          <a:xfrm>
            <a:off x="2585880" y="922320"/>
            <a:ext cx="1987560" cy="20448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6" descr="A brain with colorful spots&#10;&#10;Description automatically generated with medium confidence"/>
          <p:cNvPicPr/>
          <p:nvPr/>
        </p:nvPicPr>
        <p:blipFill>
          <a:blip r:embed="rId3"/>
          <a:srcRect l="35828" t="15453" r="37096" b="17156"/>
          <a:stretch/>
        </p:blipFill>
        <p:spPr>
          <a:xfrm>
            <a:off x="4695840" y="512640"/>
            <a:ext cx="1986120" cy="2427480"/>
          </a:xfrm>
          <a:prstGeom prst="rect">
            <a:avLst/>
          </a:prstGeom>
          <a:ln w="0">
            <a:noFill/>
          </a:ln>
        </p:spPr>
      </p:pic>
      <p:sp>
        <p:nvSpPr>
          <p:cNvPr id="45" name="TextBox 7"/>
          <p:cNvSpPr/>
          <p:nvPr/>
        </p:nvSpPr>
        <p:spPr>
          <a:xfrm>
            <a:off x="3287880" y="568440"/>
            <a:ext cx="185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Lag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Picture 9" descr="A white brain with multicolored objects on it&#10;&#10;Description automatically generated"/>
          <p:cNvPicPr/>
          <p:nvPr/>
        </p:nvPicPr>
        <p:blipFill>
          <a:blip r:embed="rId4"/>
          <a:srcRect l="32263" t="22132" r="33907" b="20651"/>
          <a:stretch/>
        </p:blipFill>
        <p:spPr>
          <a:xfrm>
            <a:off x="92160" y="6904080"/>
            <a:ext cx="2511360" cy="208440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0" descr="A close up of a brain&#10;&#10;Description automatically generated"/>
          <p:cNvPicPr/>
          <p:nvPr/>
        </p:nvPicPr>
        <p:blipFill>
          <a:blip r:embed="rId5"/>
          <a:srcRect l="36005" t="20613" r="36540" b="20651"/>
          <a:stretch/>
        </p:blipFill>
        <p:spPr>
          <a:xfrm>
            <a:off x="2611440" y="6848640"/>
            <a:ext cx="2038320" cy="213984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11" descr="A close up of a brain&#10;&#10;Description automatically generated"/>
          <p:cNvPicPr/>
          <p:nvPr/>
        </p:nvPicPr>
        <p:blipFill>
          <a:blip r:embed="rId6"/>
          <a:srcRect l="37047" t="16612" r="36932" b="17201"/>
          <a:stretch/>
        </p:blipFill>
        <p:spPr>
          <a:xfrm>
            <a:off x="4689360" y="6531120"/>
            <a:ext cx="1992600" cy="248760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9" name=""/>
          <p:cNvGraphicFramePr/>
          <p:nvPr/>
        </p:nvGraphicFramePr>
        <p:xfrm>
          <a:off x="122400" y="9043920"/>
          <a:ext cx="6613200" cy="2533680"/>
        </p:xfrm>
        <a:graphic>
          <a:graphicData uri="http://schemas.openxmlformats.org/drawingml/2006/table">
            <a:tbl>
              <a:tblPr/>
              <a:tblGrid>
                <a:gridCol w="353880"/>
                <a:gridCol w="447480"/>
                <a:gridCol w="517680"/>
                <a:gridCol w="803160"/>
                <a:gridCol w="720720"/>
                <a:gridCol w="701640"/>
                <a:gridCol w="344520"/>
                <a:gridCol w="2724120"/>
              </a:tblGrid>
              <a:tr h="336600"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ffc000"/>
                      </a:solidFill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z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S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ppro.P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uster Siz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cat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99880">
                <a:tc gridSpan="8"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ositive Salience Region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ffc000"/>
                      </a:solidFill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35240"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5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 w="5760">
                      <a:solidFill>
                        <a:srgbClr val="ffc000"/>
                      </a:solidFill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4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.293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4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pt-BR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upramarginal gyrus (posterior &amp; anterior), parietal operculum cortex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46040"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5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 w="5760">
                      <a:solidFill>
                        <a:srgbClr val="ffc000"/>
                      </a:solidFill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5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532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ferior temporal gyrus (temporoccipital), middle temporal gyrus (temporoccipital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34160"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5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 w="5760">
                      <a:solidFill>
                        <a:srgbClr val="ffc000"/>
                      </a:solidFill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349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ferior frontal gyrus (pars triangularis, pars operculari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91960">
                <a:tc gridSpan="8"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i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egative Salience Region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ffc000"/>
                      </a:solidFill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89800"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 w="5760">
                      <a:solidFill>
                        <a:srgbClr val="ffc000"/>
                      </a:solidFill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5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4.273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120" rIns="6120" tIns="61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120" marR="61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ecuneous cortex, intracalcarine cortex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pic>
        <p:nvPicPr>
          <p:cNvPr id="50" name="Picture 13" descr="A close up of a brain&#10;&#10;Description automatically generated"/>
          <p:cNvPicPr/>
          <p:nvPr/>
        </p:nvPicPr>
        <p:blipFill>
          <a:blip r:embed="rId7"/>
          <a:srcRect l="36400" t="16270" r="37096" b="16580"/>
          <a:stretch/>
        </p:blipFill>
        <p:spPr>
          <a:xfrm>
            <a:off x="4643280" y="11636280"/>
            <a:ext cx="2000520" cy="248760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14" descr="A grey and blue brain&#10;&#10;Description automatically generated"/>
          <p:cNvPicPr/>
          <p:nvPr/>
        </p:nvPicPr>
        <p:blipFill>
          <a:blip r:embed="rId8"/>
          <a:srcRect l="36400" t="21524" r="37096" b="20872"/>
          <a:stretch/>
        </p:blipFill>
        <p:spPr>
          <a:xfrm>
            <a:off x="2665440" y="11990520"/>
            <a:ext cx="1998720" cy="21333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15" descr="A close up of a brain&#10;&#10;Description automatically generated"/>
          <p:cNvPicPr/>
          <p:nvPr/>
        </p:nvPicPr>
        <p:blipFill>
          <a:blip r:embed="rId9"/>
          <a:srcRect l="33286" t="21524" r="33385" b="20872"/>
          <a:stretch/>
        </p:blipFill>
        <p:spPr>
          <a:xfrm>
            <a:off x="152280" y="11990520"/>
            <a:ext cx="2516400" cy="213336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3" name=""/>
          <p:cNvGraphicFramePr/>
          <p:nvPr/>
        </p:nvGraphicFramePr>
        <p:xfrm>
          <a:off x="122400" y="14476320"/>
          <a:ext cx="6613200" cy="1071720"/>
        </p:xfrm>
        <a:graphic>
          <a:graphicData uri="http://schemas.openxmlformats.org/drawingml/2006/table">
            <a:tbl>
              <a:tblPr/>
              <a:tblGrid>
                <a:gridCol w="353880"/>
                <a:gridCol w="447480"/>
                <a:gridCol w="517680"/>
                <a:gridCol w="803160"/>
                <a:gridCol w="720720"/>
                <a:gridCol w="701640"/>
                <a:gridCol w="344520"/>
                <a:gridCol w="2724120"/>
              </a:tblGrid>
              <a:tr h="336600"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x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ffc000"/>
                      </a:solidFill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z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S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ppro.P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uster Siz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cat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00240">
                <a:tc gridSpan="8">
                  <a:txBody>
                    <a:bodyPr lIns="7560" rIns="7560" tIns="75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ositive Salience Region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ffc000"/>
                      </a:solidFill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34880"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6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 w="5760">
                      <a:solidFill>
                        <a:srgbClr val="ffc000"/>
                      </a:solidFill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5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913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7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lIns="7560" rIns="7560" tIns="75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upramarginal gyrus (posterior), angular gyru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560" marR="7560">
                    <a:lnL>
                      <a:noFill/>
                    </a:lnL>
                    <a:lnR w="5760">
                      <a:solidFill>
                        <a:srgbClr val="ffc000"/>
                      </a:solidFill>
                    </a:lnR>
                    <a:lnT w="5760">
                      <a:solidFill>
                        <a:srgbClr val="ffc000"/>
                      </a:solidFill>
                    </a:lnT>
                    <a:lnB w="5760">
                      <a:solidFill>
                        <a:srgbClr val="ffc000"/>
                      </a:solidFill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54" name="TextBox 17"/>
          <p:cNvSpPr/>
          <p:nvPr/>
        </p:nvSpPr>
        <p:spPr>
          <a:xfrm>
            <a:off x="3317760" y="6531120"/>
            <a:ext cx="1854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Lag 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8"/>
          <p:cNvSpPr/>
          <p:nvPr/>
        </p:nvSpPr>
        <p:spPr>
          <a:xfrm>
            <a:off x="3348000" y="11644200"/>
            <a:ext cx="1854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Lag 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02-04T18:02:07Z</dcterms:created>
  <dc:creator>Daniela Rodriguez Manrique</dc:creator>
  <dc:description/>
  <dc:language>en-US</dc:language>
  <cp:lastModifiedBy>Daniela Rodriguez Manrique</cp:lastModifiedBy>
  <dcterms:modified xsi:type="dcterms:W3CDTF">2025-04-14T16:21:06Z</dcterms:modified>
  <cp:revision>3</cp:revision>
  <dc:subject/>
  <dc:title>PowerPoint Presentation</dc:title>
</cp:coreProperties>
</file>